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20" y="6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97F4A7-219B-4975-F60F-352D24D6F01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DC7EC8C-E8C1-53A0-6EEC-797DFA324A3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5046F48-2857-5CAC-C61F-55109E9F73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084943-28AC-BD57-5FC0-C7AB2F4C83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286E3B-3EBD-FD9B-31F9-092B3EEC5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18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F3AE47-975B-A314-9E19-1E5AFC6AD4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411DDEE-59DC-89CD-95DF-8CD1D4DA1A1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EFEDC5-33E5-A47F-BE71-778E4E650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5B6760A-913E-EFB9-3E96-D756705205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64BAA1-8D94-6BB9-69EC-95C9466969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1418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C631445-7D85-48E2-AE68-E74FD257994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85A4D8-2589-8489-617A-47F4C649ECA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05E536-6AA1-20E8-1DC9-DE2895464C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35EDD3-3632-D078-408D-89291EA875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3E7F07-DC75-8575-4D8F-A126346E22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7849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8F6DD-1BA4-3079-BD7F-C745008A0E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ABC9F9-7724-B76E-711E-A7D921917EB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96AD9A-E59D-A309-5D00-E67275CD7A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93A760-7D4F-852B-22C9-5DB353B2AF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1054BA5-8F5C-8705-1216-CF5AB4E63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1976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CBFD44-2D8B-1E37-F7D8-E12BBB4461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2A67CC1-1CF6-DC87-FE85-6D0E56E146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BE7B3F-E706-1BF3-C2BC-E81063BB8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FB2C01-1973-ED3C-9424-C2325BF8D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4724D1-6CA7-2A2E-2182-A49BBCBD14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3004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20134E-BF40-825B-7413-A100C466BF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ABCDCE-678A-8539-5BC8-737CC32C86C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FF83F5D-F944-60EE-4D84-F7C97E4565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1B09E89-ACF4-E3AE-A07D-7F80DC3A5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BD8FD2-0349-D511-6D95-55173593BF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B88BC29-F215-839F-CCF9-BA944BC8E7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66999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E6FE00-CFED-8C6D-A359-51D572543E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01FF75-2E6E-5791-E003-C9E3FB309B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62CD24-3C92-5D4E-E8AE-300E9923F6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2561811-0E2B-EE00-0FC8-4AF273A9511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E05F79B-54F6-571C-8428-773F6D65AA5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CFC8833-1D20-8B73-04F9-A774049F49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AC3739A-E71D-39AB-45ED-CB3C985080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74E2AA3-27BD-DC24-9B1E-E2C6C44199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20417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A50B7-C26F-335D-AC6E-355C274FA5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70B077-8971-A435-C0EE-6084589999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77E76A-52F8-DE6B-BC26-FA5B87F975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AD2481C-8165-E789-A88E-CA1EC6D76F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0882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E6507E3-5E80-BE14-DF4F-F8A99ADB19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1912C52-C8B2-3666-5866-AB69D060F8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D5776D1-FC71-8592-62B1-063633AF20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3009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7A703A-4586-16E6-4B07-D7EE528696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64E8BD-3C0C-9BAA-45A7-4C409454A4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E37B707-A4F9-1860-169A-1470B5B9F73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887A4D-13CB-E3D0-9C4A-2386C68CE1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25AE695-B5C6-A199-551F-FFAA9F20C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BE90F7D-496B-498C-311E-B2DD801036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63580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701139-0A7E-1926-EED7-152EEBAD96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E02BE2D-C53B-AC3C-1BA8-B6CFF60B9D8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8747EC9-B127-EB7B-93DF-14824D97122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8EBBF22-3E71-8A20-2816-1A0AE6C06C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0D30321-BCF4-6E6A-8ADB-EDC115369C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DE5DBF-42CA-3299-B42C-F830224A85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42321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4DC469B-06CD-53A2-6B05-B73EC5CA58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1840D0-86AD-05D8-EFEA-072571A3C8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A4A65F-91AD-364D-6089-C504CC9C385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81DBAE-49F4-48C7-8F44-6A89EC4B22B8}" type="datetimeFigureOut">
              <a:rPr lang="en-US" smtClean="0"/>
              <a:t>7/28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FFB0DC-19EE-7F43-5DFA-CF968842E8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0E8C3D-0844-8BB1-E9D6-146832FFEE4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5B0B29-FD52-43BE-8BF2-923E508985B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3003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C608385A-BA72-D6F5-46FD-4A5F43DD6D3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6829" y="717120"/>
            <a:ext cx="3970020" cy="2482596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6998C83E-3613-8DD2-DE2D-BB427238BF3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66849" y="717120"/>
            <a:ext cx="3889248" cy="255422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EF624BF-FCD8-7D64-827F-FA77BF38B54E}"/>
              </a:ext>
            </a:extLst>
          </p:cNvPr>
          <p:cNvSpPr txBox="1"/>
          <p:nvPr/>
        </p:nvSpPr>
        <p:spPr>
          <a:xfrm>
            <a:off x="396829" y="3199716"/>
            <a:ext cx="8023053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Supplementary Figure 2. Cellular efficacy of ZL-2201 across cancer cell lines. </a:t>
            </a:r>
            <a:r>
              <a:rPr lang="en-US" sz="1600" dirty="0"/>
              <a:t>Representative IC50 curves for cell lines treated with ZL-2201 for 6 days. Percentage growth was determined by Cell-Titer Glo Assay and curves were produced using GraphPad Prism software</a:t>
            </a:r>
            <a:r>
              <a:rPr lang="en-US" dirty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4287572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</TotalTime>
  <Words>43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il Bhola</dc:creator>
  <cp:lastModifiedBy>Neil Bhola</cp:lastModifiedBy>
  <cp:revision>1</cp:revision>
  <dcterms:created xsi:type="dcterms:W3CDTF">2023-07-28T20:25:33Z</dcterms:created>
  <dcterms:modified xsi:type="dcterms:W3CDTF">2023-07-28T20:35:45Z</dcterms:modified>
</cp:coreProperties>
</file>